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1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72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7/08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39066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8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8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8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8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8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8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8/2023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8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8/2023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8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8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7/08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95536" y="5347451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Goldney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3) Diabetologia DOI 10.1007/s00125-021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5988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3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3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Pathophysiology of microvascular disease in diabetes and protective actions of incretin-based therapies beyond glucose-lowering effects</a:t>
            </a:r>
            <a:endParaRPr lang="en-GB" sz="18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B71B851-C811-7AD4-A5B3-7879D7E2D67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87800" y="1183885"/>
            <a:ext cx="6568399" cy="44902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A summary of the observational and trial evidence for incretin-based therapies and microvascular diseases</a:t>
            </a:r>
            <a:endParaRPr lang="en-GB" sz="18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D385791-A520-D492-4E46-FBEAEDC4534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39752" y="1027875"/>
            <a:ext cx="4464496" cy="480225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26C1E0B2-954D-1D71-82E1-AAF4A8DABB10}"/>
              </a:ext>
            </a:extLst>
          </p:cNvPr>
          <p:cNvSpPr txBox="1"/>
          <p:nvPr/>
        </p:nvSpPr>
        <p:spPr>
          <a:xfrm>
            <a:off x="395536" y="5347451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Goldney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3) Diabetologia DOI 10.1007/s00125-021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5988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3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3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5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3700470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1</Words>
  <Application>Microsoft Office PowerPoint</Application>
  <PresentationFormat>On-screen Show (4:3)</PresentationFormat>
  <Paragraphs>12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Editorial Office</cp:lastModifiedBy>
  <cp:revision>43</cp:revision>
  <dcterms:created xsi:type="dcterms:W3CDTF">2016-06-15T12:53:43Z</dcterms:created>
  <dcterms:modified xsi:type="dcterms:W3CDTF">2023-08-07T10:50:02Z</dcterms:modified>
</cp:coreProperties>
</file>